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E52612-09BF-4C24-BC5D-34DA883DAC7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C34033-0B43-47FC-BC8A-8FA79F3CA91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0AEF4-200C-446F-8C96-9410778953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F81D9-3C76-41B3-8E95-037221D346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DB34BC-5272-40C8-9E07-7F95474624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101F1-5809-4727-8946-9AB6A2F374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E82DC-EFFD-4980-9CAD-E4776C0997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4D097-5A56-4014-85BE-42B035A179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8D4C56-E076-49E1-974B-7EF7B3A173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7028E-7A74-4D04-A4F6-05BDA6CEE6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5A908-6DC2-402C-9B26-BF14E2C62C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99E80-1C77-4A2A-BD81-66DA96A883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9933F-24B8-43D8-A3C3-0981C627D3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0532F-90D7-4A31-B35A-B8E9542816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BE231E-DD02-4318-ADC2-3563963A52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3" descr=""/>
          <p:cNvPicPr/>
          <p:nvPr/>
        </p:nvPicPr>
        <p:blipFill>
          <a:blip r:embed="rId1"/>
          <a:srcRect l="0" t="7936" r="0" b="6348"/>
          <a:stretch/>
        </p:blipFill>
        <p:spPr>
          <a:xfrm>
            <a:off x="338040" y="3336840"/>
            <a:ext cx="6351840" cy="381024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"/>
          <p:cNvSpPr/>
          <p:nvPr/>
        </p:nvSpPr>
        <p:spPr>
          <a:xfrm>
            <a:off x="1450800" y="7070760"/>
            <a:ext cx="389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be position (in MB) within chromosomes in the B73 RefGen_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6121440" y="6378480"/>
            <a:ext cx="384120" cy="480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8"/>
          <p:cNvSpPr/>
          <p:nvPr/>
        </p:nvSpPr>
        <p:spPr>
          <a:xfrm>
            <a:off x="6046200" y="6346800"/>
            <a:ext cx="4885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Perfect match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6046200" y="6438960"/>
            <a:ext cx="56484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Highly conserve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"/>
          <p:cNvSpPr/>
          <p:nvPr/>
        </p:nvSpPr>
        <p:spPr>
          <a:xfrm>
            <a:off x="6046200" y="6649920"/>
            <a:ext cx="5677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Poorly conserve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1"/>
          <p:cNvSpPr/>
          <p:nvPr/>
        </p:nvSpPr>
        <p:spPr>
          <a:xfrm>
            <a:off x="6044760" y="6537240"/>
            <a:ext cx="4230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2"/>
          <p:cNvSpPr/>
          <p:nvPr/>
        </p:nvSpPr>
        <p:spPr>
          <a:xfrm>
            <a:off x="6044760" y="6735600"/>
            <a:ext cx="3942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No match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" descr=""/>
          <p:cNvPicPr/>
          <p:nvPr/>
        </p:nvPicPr>
        <p:blipFill>
          <a:blip r:embed="rId2"/>
          <a:stretch/>
        </p:blipFill>
        <p:spPr>
          <a:xfrm>
            <a:off x="4927680" y="5794200"/>
            <a:ext cx="1600200" cy="1098720"/>
          </a:xfrm>
          <a:prstGeom prst="rect">
            <a:avLst/>
          </a:prstGeom>
          <a:ln w="0">
            <a:noFill/>
          </a:ln>
        </p:spPr>
      </p:pic>
      <p:sp>
        <p:nvSpPr>
          <p:cNvPr id="57" name="Rectangle 20"/>
          <p:cNvSpPr/>
          <p:nvPr/>
        </p:nvSpPr>
        <p:spPr>
          <a:xfrm>
            <a:off x="5695920" y="6834240"/>
            <a:ext cx="45720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1"/>
          <p:cNvSpPr/>
          <p:nvPr/>
        </p:nvSpPr>
        <p:spPr>
          <a:xfrm>
            <a:off x="5344200" y="6797520"/>
            <a:ext cx="6775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Highly conserved 16%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2"/>
          <p:cNvSpPr/>
          <p:nvPr/>
        </p:nvSpPr>
        <p:spPr>
          <a:xfrm>
            <a:off x="5079960" y="5861160"/>
            <a:ext cx="457200" cy="7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3"/>
          <p:cNvSpPr/>
          <p:nvPr/>
        </p:nvSpPr>
        <p:spPr>
          <a:xfrm>
            <a:off x="5186160" y="5829480"/>
            <a:ext cx="5068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No match 10%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4"/>
          <p:cNvSpPr/>
          <p:nvPr/>
        </p:nvSpPr>
        <p:spPr>
          <a:xfrm>
            <a:off x="5079960" y="6045120"/>
            <a:ext cx="22212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5"/>
          <p:cNvSpPr/>
          <p:nvPr/>
        </p:nvSpPr>
        <p:spPr>
          <a:xfrm>
            <a:off x="5007960" y="5921280"/>
            <a:ext cx="42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Poorly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9%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6"/>
          <p:cNvSpPr/>
          <p:nvPr/>
        </p:nvSpPr>
        <p:spPr>
          <a:xfrm>
            <a:off x="4927680" y="6519960"/>
            <a:ext cx="304560" cy="7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9"/>
          <p:cNvSpPr/>
          <p:nvPr/>
        </p:nvSpPr>
        <p:spPr>
          <a:xfrm>
            <a:off x="6127920" y="6208560"/>
            <a:ext cx="45720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7"/>
          <p:cNvSpPr/>
          <p:nvPr/>
        </p:nvSpPr>
        <p:spPr>
          <a:xfrm>
            <a:off x="4781160" y="6480000"/>
            <a:ext cx="5356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Conserved 24%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4"/>
          <p:cNvSpPr/>
          <p:nvPr/>
        </p:nvSpPr>
        <p:spPr>
          <a:xfrm>
            <a:off x="6050880" y="6164280"/>
            <a:ext cx="6012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Perfect match 41%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20:40Z</dcterms:modified>
  <cp:revision>28</cp:revision>
  <dc:subject/>
  <dc:title>Slide 1</dc:title>
</cp:coreProperties>
</file>